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8183563" cy="35496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CB4D00-5EB2-41FD-9FFB-4449776303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15960" y="1025280"/>
            <a:ext cx="695160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15960" y="2137320"/>
            <a:ext cx="695160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8B6BE-118D-430F-BF58-34FB1FFA3A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15960" y="1025280"/>
            <a:ext cx="339228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178160" y="1025280"/>
            <a:ext cx="339228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15960" y="2137320"/>
            <a:ext cx="339228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178160" y="2137320"/>
            <a:ext cx="339228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D6A69-5F7B-4BB4-B0D1-1A1F6CF92E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15960" y="1025280"/>
            <a:ext cx="223812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966400" y="1025280"/>
            <a:ext cx="223812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316840" y="1025280"/>
            <a:ext cx="223812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15960" y="2137320"/>
            <a:ext cx="223812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966400" y="2137320"/>
            <a:ext cx="223812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316840" y="2137320"/>
            <a:ext cx="223812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6AEB60-5B83-4B08-B386-0A31BE0CDE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15960" y="1025280"/>
            <a:ext cx="6951600" cy="212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6FA05-F1DD-4F00-9522-4D990B6EA8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15960" y="1025280"/>
            <a:ext cx="6951600" cy="212868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2C25F-B38B-48E2-90A7-B1596E6A63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15960" y="1025280"/>
            <a:ext cx="3392280" cy="212868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178160" y="1025280"/>
            <a:ext cx="3392280" cy="212868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80755C-124B-4088-B980-0138F2E346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DB113-A8BA-4941-99EF-A959DAB74D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15960" y="316080"/>
            <a:ext cx="6951600" cy="273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1B84C-DC29-4012-9E6F-5C72FBFED7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15960" y="1025280"/>
            <a:ext cx="339228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178160" y="1025280"/>
            <a:ext cx="3392280" cy="212868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15960" y="2137320"/>
            <a:ext cx="339228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67F69-2129-4F61-85B1-61599A37D4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15960" y="1025280"/>
            <a:ext cx="3392280" cy="212868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178160" y="1025280"/>
            <a:ext cx="339228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178160" y="2137320"/>
            <a:ext cx="339228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EC4C3-9161-4E88-BC18-043FD1CB04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15960" y="1025280"/>
            <a:ext cx="339228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178160" y="1025280"/>
            <a:ext cx="339228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15960" y="2137320"/>
            <a:ext cx="6951600" cy="10152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71D8E4-9902-4FC4-8982-34A42D128A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15960" y="316080"/>
            <a:ext cx="6951600" cy="59040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ctr">
            <a:noAutofit/>
          </a:bodyPr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3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15960" y="1025280"/>
            <a:ext cx="6951600" cy="212868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rmAutofit fontScale="65000"/>
          </a:bodyPr>
          <a:p>
            <a:pPr marL="171000" indent="-171000">
              <a:spcBef>
                <a:spcPts val="624"/>
              </a:spcBef>
              <a:buClr>
                <a:srgbClr val="000000"/>
              </a:buClr>
              <a:buFont typeface="Times"/>
              <a:buChar char="•"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  <a:p>
            <a:pPr lvl="1" marL="372240" indent="-143280">
              <a:spcBef>
                <a:spcPts val="624"/>
              </a:spcBef>
              <a:buClr>
                <a:srgbClr val="000000"/>
              </a:buClr>
              <a:buFont typeface="Times"/>
              <a:buChar char="–"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  <a:p>
            <a:pPr lvl="2" marL="572400" indent="-114120">
              <a:spcBef>
                <a:spcPts val="624"/>
              </a:spcBef>
              <a:buClr>
                <a:srgbClr val="000000"/>
              </a:buClr>
              <a:buFont typeface="Times"/>
              <a:buChar char="•"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  <a:p>
            <a:pPr lvl="3" marL="801360" indent="-114120">
              <a:spcBef>
                <a:spcPts val="624"/>
              </a:spcBef>
              <a:buClr>
                <a:srgbClr val="000000"/>
              </a:buClr>
              <a:buFont typeface="Times"/>
              <a:buChar char="–"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  <a:p>
            <a:pPr lvl="4" marL="1030680" indent="-115560">
              <a:spcBef>
                <a:spcPts val="624"/>
              </a:spcBef>
              <a:buClr>
                <a:srgbClr val="000000"/>
              </a:buClr>
              <a:buFont typeface="Times"/>
              <a:buChar char="»"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  <a:p>
            <a:pPr lvl="5" marL="1030680" indent="-115560">
              <a:spcBef>
                <a:spcPts val="624"/>
              </a:spcBef>
              <a:buClr>
                <a:srgbClr val="000000"/>
              </a:buClr>
              <a:buFont typeface="Times"/>
              <a:buChar char="»"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  <a:p>
            <a:pPr lvl="6" marL="1030680" indent="-115560">
              <a:spcBef>
                <a:spcPts val="624"/>
              </a:spcBef>
              <a:buClr>
                <a:srgbClr val="000000"/>
              </a:buClr>
              <a:buFont typeface="Times"/>
              <a:buChar char="»"/>
              <a:tabLst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15600" y="3231720"/>
            <a:ext cx="1701720" cy="23652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Autofit/>
          </a:bodyPr>
          <a:lstStyle>
            <a:lvl1pPr indent="0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795400" y="3231720"/>
            <a:ext cx="2592360" cy="23652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Autofit/>
          </a:bodyPr>
          <a:lstStyle>
            <a:lvl1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865480" y="3231720"/>
            <a:ext cx="1701720" cy="236520"/>
          </a:xfrm>
          <a:prstGeom prst="rect">
            <a:avLst/>
          </a:prstGeom>
          <a:noFill/>
          <a:ln w="0">
            <a:noFill/>
          </a:ln>
        </p:spPr>
        <p:txBody>
          <a:bodyPr lIns="70560" rIns="70560" tIns="35280" bIns="35280" anchor="t">
            <a:noAutofit/>
          </a:bodyPr>
          <a:lstStyle>
            <a:lvl1pPr indent="0" algn="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704880"/>
                <a:tab algn="l" pos="1409760"/>
                <a:tab algn="l" pos="2114640"/>
                <a:tab algn="l" pos="2819520"/>
                <a:tab algn="l" pos="3524400"/>
                <a:tab algn="l" pos="4229280"/>
                <a:tab algn="l" pos="4933800"/>
                <a:tab algn="l" pos="5638680"/>
                <a:tab algn="l" pos="6343560"/>
                <a:tab algn="l" pos="7048440"/>
                <a:tab algn="l" pos="7753320"/>
                <a:tab algn="l" pos="8458200"/>
                <a:tab algn="l" pos="9163080"/>
                <a:tab algn="l" pos="9867960"/>
                <a:tab algn="l" pos="10572840"/>
              </a:tabLst>
            </a:pPr>
            <a:fld id="{5A73E8A6-C807-432B-AD56-87C0E38C65B5}" type="slidenum"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440" y="5760"/>
            <a:ext cx="8167320" cy="3539160"/>
            <a:chOff x="10440" y="5760"/>
            <a:chExt cx="8167320" cy="3539160"/>
          </a:xfrm>
        </p:grpSpPr>
        <p:sp>
          <p:nvSpPr>
            <p:cNvPr id="42" name="Line 2"/>
            <p:cNvSpPr/>
            <p:nvPr/>
          </p:nvSpPr>
          <p:spPr>
            <a:xfrm>
              <a:off x="647640" y="1128600"/>
              <a:ext cx="7030800" cy="79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Line 4"/>
            <p:cNvSpPr/>
            <p:nvPr/>
          </p:nvSpPr>
          <p:spPr>
            <a:xfrm>
              <a:off x="2916000" y="920520"/>
              <a:ext cx="0" cy="20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Line 5"/>
            <p:cNvSpPr/>
            <p:nvPr/>
          </p:nvSpPr>
          <p:spPr>
            <a:xfrm>
              <a:off x="3201840" y="920520"/>
              <a:ext cx="0" cy="174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Line 6"/>
            <p:cNvSpPr/>
            <p:nvPr/>
          </p:nvSpPr>
          <p:spPr>
            <a:xfrm flipH="1">
              <a:off x="3402000" y="919080"/>
              <a:ext cx="2880" cy="18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Line 7"/>
            <p:cNvSpPr/>
            <p:nvPr/>
          </p:nvSpPr>
          <p:spPr>
            <a:xfrm>
              <a:off x="6800760" y="914400"/>
              <a:ext cx="3240" cy="174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Rectangle 8"/>
            <p:cNvSpPr/>
            <p:nvPr/>
          </p:nvSpPr>
          <p:spPr>
            <a:xfrm rot="16200000">
              <a:off x="2794680" y="280800"/>
              <a:ext cx="82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g AUG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Rectangle 9"/>
            <p:cNvSpPr/>
            <p:nvPr/>
          </p:nvSpPr>
          <p:spPr>
            <a:xfrm rot="16200000">
              <a:off x="3070800" y="286920"/>
              <a:ext cx="81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nv UAG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Rectangle 10"/>
            <p:cNvSpPr/>
            <p:nvPr/>
          </p:nvSpPr>
          <p:spPr>
            <a:xfrm>
              <a:off x="2697480" y="1279440"/>
              <a:ext cx="51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 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Rectangle 12"/>
            <p:cNvSpPr/>
            <p:nvPr/>
          </p:nvSpPr>
          <p:spPr>
            <a:xfrm>
              <a:off x="2656440" y="73800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305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Rectangle 13"/>
            <p:cNvSpPr/>
            <p:nvPr/>
          </p:nvSpPr>
          <p:spPr>
            <a:xfrm>
              <a:off x="4997520" y="1771560"/>
              <a:ext cx="196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 defined in Mullner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t al.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Rectangle 14"/>
            <p:cNvSpPr/>
            <p:nvPr/>
          </p:nvSpPr>
          <p:spPr>
            <a:xfrm rot="16200000">
              <a:off x="6397560" y="289440"/>
              <a:ext cx="81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g UAA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Rectangle 15"/>
            <p:cNvSpPr/>
            <p:nvPr/>
          </p:nvSpPr>
          <p:spPr>
            <a:xfrm>
              <a:off x="2989800" y="73656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378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Rectangle 16"/>
            <p:cNvSpPr/>
            <p:nvPr/>
          </p:nvSpPr>
          <p:spPr>
            <a:xfrm>
              <a:off x="3280320" y="73800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43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Line 17"/>
            <p:cNvSpPr/>
            <p:nvPr/>
          </p:nvSpPr>
          <p:spPr>
            <a:xfrm>
              <a:off x="2862000" y="1931760"/>
              <a:ext cx="10684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Line 18"/>
            <p:cNvSpPr/>
            <p:nvPr/>
          </p:nvSpPr>
          <p:spPr>
            <a:xfrm>
              <a:off x="3044520" y="2203200"/>
              <a:ext cx="1811520" cy="1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Line 19"/>
            <p:cNvSpPr/>
            <p:nvPr/>
          </p:nvSpPr>
          <p:spPr>
            <a:xfrm flipV="1">
              <a:off x="2869920" y="2476080"/>
              <a:ext cx="2268720" cy="6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Line 20"/>
            <p:cNvSpPr/>
            <p:nvPr/>
          </p:nvSpPr>
          <p:spPr>
            <a:xfrm>
              <a:off x="3047760" y="3132000"/>
              <a:ext cx="4684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Line 21"/>
            <p:cNvSpPr/>
            <p:nvPr/>
          </p:nvSpPr>
          <p:spPr>
            <a:xfrm>
              <a:off x="1725480" y="3404880"/>
              <a:ext cx="6006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Rectangle 23"/>
            <p:cNvSpPr/>
            <p:nvPr/>
          </p:nvSpPr>
          <p:spPr>
            <a:xfrm>
              <a:off x="5335560" y="2055600"/>
              <a:ext cx="184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 defined in Mertz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t al.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Rectangle 24"/>
            <p:cNvSpPr/>
            <p:nvPr/>
          </p:nvSpPr>
          <p:spPr>
            <a:xfrm>
              <a:off x="11520" y="2373120"/>
              <a:ext cx="738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RmR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Rectangle 25"/>
            <p:cNvSpPr/>
            <p:nvPr/>
          </p:nvSpPr>
          <p:spPr>
            <a:xfrm>
              <a:off x="10440" y="2970000"/>
              <a:ext cx="72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TRgag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Rectangle 26"/>
            <p:cNvSpPr/>
            <p:nvPr/>
          </p:nvSpPr>
          <p:spPr>
            <a:xfrm>
              <a:off x="10440" y="3268440"/>
              <a:ext cx="76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TR+SA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Rectangle 27"/>
            <p:cNvSpPr/>
            <p:nvPr/>
          </p:nvSpPr>
          <p:spPr>
            <a:xfrm>
              <a:off x="2443680" y="182376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29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Rectangle 28"/>
            <p:cNvSpPr/>
            <p:nvPr/>
          </p:nvSpPr>
          <p:spPr>
            <a:xfrm>
              <a:off x="3931200" y="182376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57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Rectangle 29"/>
            <p:cNvSpPr/>
            <p:nvPr/>
          </p:nvSpPr>
          <p:spPr>
            <a:xfrm>
              <a:off x="2626200" y="209844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338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Rectangle 30"/>
            <p:cNvSpPr/>
            <p:nvPr/>
          </p:nvSpPr>
          <p:spPr>
            <a:xfrm>
              <a:off x="4856760" y="208584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813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Rectangle 31"/>
            <p:cNvSpPr/>
            <p:nvPr/>
          </p:nvSpPr>
          <p:spPr>
            <a:xfrm>
              <a:off x="2443680" y="237492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291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Rectangle 32"/>
            <p:cNvSpPr/>
            <p:nvPr/>
          </p:nvSpPr>
          <p:spPr>
            <a:xfrm>
              <a:off x="5140800" y="237492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886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Rectangle 33"/>
            <p:cNvSpPr/>
            <p:nvPr/>
          </p:nvSpPr>
          <p:spPr>
            <a:xfrm>
              <a:off x="2612160" y="302256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338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Rectangle 34"/>
            <p:cNvSpPr/>
            <p:nvPr/>
          </p:nvSpPr>
          <p:spPr>
            <a:xfrm>
              <a:off x="1307160" y="329868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993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Rectangle 35"/>
            <p:cNvSpPr/>
            <p:nvPr/>
          </p:nvSpPr>
          <p:spPr>
            <a:xfrm>
              <a:off x="7741080" y="101736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564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Rectangle 36"/>
            <p:cNvSpPr/>
            <p:nvPr/>
          </p:nvSpPr>
          <p:spPr>
            <a:xfrm>
              <a:off x="229320" y="101916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709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Rectangle 37"/>
            <p:cNvSpPr/>
            <p:nvPr/>
          </p:nvSpPr>
          <p:spPr>
            <a:xfrm>
              <a:off x="7741080" y="302256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564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Rectangle 38"/>
            <p:cNvSpPr/>
            <p:nvPr/>
          </p:nvSpPr>
          <p:spPr>
            <a:xfrm>
              <a:off x="7741080" y="329868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564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Rectangle 42"/>
            <p:cNvSpPr/>
            <p:nvPr/>
          </p:nvSpPr>
          <p:spPr>
            <a:xfrm>
              <a:off x="3190680" y="1027080"/>
              <a:ext cx="4470480" cy="18720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Rectangle 44"/>
            <p:cNvSpPr/>
            <p:nvPr/>
          </p:nvSpPr>
          <p:spPr>
            <a:xfrm>
              <a:off x="6585480" y="73656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325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Rectangle 45"/>
            <p:cNvSpPr/>
            <p:nvPr/>
          </p:nvSpPr>
          <p:spPr>
            <a:xfrm>
              <a:off x="5248440" y="1199880"/>
              <a:ext cx="37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U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Rectangle 46"/>
            <p:cNvSpPr/>
            <p:nvPr/>
          </p:nvSpPr>
          <p:spPr>
            <a:xfrm>
              <a:off x="7556040" y="119844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Rectangle 48"/>
            <p:cNvSpPr/>
            <p:nvPr/>
          </p:nvSpPr>
          <p:spPr>
            <a:xfrm>
              <a:off x="7667280" y="1028520"/>
              <a:ext cx="60480" cy="182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AutoShape 52"/>
            <p:cNvSpPr/>
            <p:nvPr/>
          </p:nvSpPr>
          <p:spPr>
            <a:xfrm>
              <a:off x="2842920" y="1155600"/>
              <a:ext cx="127080" cy="166680"/>
            </a:xfrm>
            <a:prstGeom prst="triangle">
              <a:avLst>
                <a:gd name="adj" fmla="val 50000"/>
              </a:avLst>
            </a:prstGeom>
            <a:solidFill>
              <a:srgbClr val="ff8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9000" bIns="90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Rectangle 24"/>
            <p:cNvSpPr/>
            <p:nvPr/>
          </p:nvSpPr>
          <p:spPr>
            <a:xfrm>
              <a:off x="11520" y="2071440"/>
              <a:ext cx="62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mR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Rectangle 24"/>
            <p:cNvSpPr/>
            <p:nvPr/>
          </p:nvSpPr>
          <p:spPr>
            <a:xfrm>
              <a:off x="11520" y="1771560"/>
              <a:ext cx="62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mR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Rectangle 24"/>
            <p:cNvSpPr/>
            <p:nvPr/>
          </p:nvSpPr>
          <p:spPr>
            <a:xfrm>
              <a:off x="11520" y="2671560"/>
              <a:ext cx="89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ssRmR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Rectangle 24"/>
            <p:cNvSpPr/>
            <p:nvPr/>
          </p:nvSpPr>
          <p:spPr>
            <a:xfrm>
              <a:off x="38520" y="1238040"/>
              <a:ext cx="203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MTV Mtv-1 genomic RNA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Straight Connector 2"/>
            <p:cNvSpPr/>
            <p:nvPr/>
          </p:nvSpPr>
          <p:spPr>
            <a:xfrm flipH="1">
              <a:off x="593280" y="982440"/>
              <a:ext cx="168120" cy="236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Line 21"/>
            <p:cNvSpPr/>
            <p:nvPr/>
          </p:nvSpPr>
          <p:spPr>
            <a:xfrm flipV="1">
              <a:off x="1725480" y="2801520"/>
              <a:ext cx="6006960" cy="6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Rectangle 34"/>
            <p:cNvSpPr/>
            <p:nvPr/>
          </p:nvSpPr>
          <p:spPr>
            <a:xfrm>
              <a:off x="1307160" y="270180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993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Rectangle 38"/>
            <p:cNvSpPr/>
            <p:nvPr/>
          </p:nvSpPr>
          <p:spPr>
            <a:xfrm>
              <a:off x="7741080" y="2682720"/>
              <a:ext cx="436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564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Straight Connector 51"/>
            <p:cNvSpPr/>
            <p:nvPr/>
          </p:nvSpPr>
          <p:spPr>
            <a:xfrm flipH="1">
              <a:off x="1644120" y="2685960"/>
              <a:ext cx="168120" cy="236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06T20:47:10Z</dcterms:created>
  <dc:creator>John West</dc:creator>
  <dc:description/>
  <dc:language>en-US</dc:language>
  <cp:lastModifiedBy>Ioana Boeras</cp:lastModifiedBy>
  <dcterms:modified xsi:type="dcterms:W3CDTF">2012-01-06T22:01:40Z</dcterms:modified>
  <cp:revision>5</cp:revision>
  <dc:subject/>
  <dc:title>PowerPoint Presentation</dc:title>
</cp:coreProperties>
</file>